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1" r:id="rId2"/>
  </p:sldIdLst>
  <p:sldSz cx="12192000" cy="6858000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보통 스타일 2 - 강조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987" autoAdjust="0"/>
    <p:restoredTop sz="94660"/>
  </p:normalViewPr>
  <p:slideViewPr>
    <p:cSldViewPr snapToGrid="0">
      <p:cViewPr varScale="1">
        <p:scale>
          <a:sx n="114" d="100"/>
          <a:sy n="114" d="100"/>
        </p:scale>
        <p:origin x="414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DEE9A2A9-2CD4-4322-A1CE-3FCA86674C02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부제목 2">
            <a:extLst>
              <a:ext uri="{FF2B5EF4-FFF2-40B4-BE49-F238E27FC236}">
                <a16:creationId xmlns:a16="http://schemas.microsoft.com/office/drawing/2014/main" id="{A00B65BC-D98C-41C9-93DC-6FB325423D64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ko-KR" altLang="en-US"/>
              <a:t>클릭하여 마스터 부제목 스타일 편집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3C268BB4-2B1B-4EFD-873D-6E305AE8988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14C2BD-E780-4893-B69C-FEB67E170F35}" type="datetimeFigureOut">
              <a:rPr lang="ko-KR" altLang="en-US" smtClean="0"/>
              <a:t>2021-01-06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E70C130D-B336-4A67-ABEE-22367BB6E4E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01FC517D-3E94-473B-90E9-51A26B82F0E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6278D1-F831-4508-A8C3-E13F3D06CB6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04532012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6FDCA571-9662-499A-A9B9-4D7437FDB32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>
            <a:extLst>
              <a:ext uri="{FF2B5EF4-FFF2-40B4-BE49-F238E27FC236}">
                <a16:creationId xmlns:a16="http://schemas.microsoft.com/office/drawing/2014/main" id="{E1757A5B-62A3-4574-AF2B-E4C5E4A1C52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BF31D957-91A2-431A-863F-5BBF5006178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14C2BD-E780-4893-B69C-FEB67E170F35}" type="datetimeFigureOut">
              <a:rPr lang="ko-KR" altLang="en-US" smtClean="0"/>
              <a:t>2021-01-06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74B777DA-62B8-40FF-982A-0E1D8929926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565478B2-C02B-4B7F-B2E4-EB4A921335D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6278D1-F831-4508-A8C3-E13F3D06CB6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0729176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>
            <a:extLst>
              <a:ext uri="{FF2B5EF4-FFF2-40B4-BE49-F238E27FC236}">
                <a16:creationId xmlns:a16="http://schemas.microsoft.com/office/drawing/2014/main" id="{9B64F367-4219-4253-BC3D-C72E2A5B5B15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>
            <a:extLst>
              <a:ext uri="{FF2B5EF4-FFF2-40B4-BE49-F238E27FC236}">
                <a16:creationId xmlns:a16="http://schemas.microsoft.com/office/drawing/2014/main" id="{6510E338-4016-4A7A-AAF0-E4AD569E7B9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90A6D684-4D21-4D36-8F98-BD932A4FD6F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14C2BD-E780-4893-B69C-FEB67E170F35}" type="datetimeFigureOut">
              <a:rPr lang="ko-KR" altLang="en-US" smtClean="0"/>
              <a:t>2021-01-06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1D6D0340-55F6-42C6-A31D-6FB231C964C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5B30FB00-50C6-4E52-BE6E-8ED17C9EB01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6278D1-F831-4508-A8C3-E13F3D06CB6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39705759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0C5A8F0C-5046-4EFD-894E-A5675F65026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300C106C-AB0D-425D-89C0-634D8363EF63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3F30657F-0F5A-4A0C-925F-AFDC45A41BF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14C2BD-E780-4893-B69C-FEB67E170F35}" type="datetimeFigureOut">
              <a:rPr lang="ko-KR" altLang="en-US" smtClean="0"/>
              <a:t>2021-01-06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2B31C42E-FD32-460D-82E5-FF2A940CCC0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34FBDD35-2FEB-472B-976B-D637D79FB82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6278D1-F831-4508-A8C3-E13F3D06CB6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06579218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07E8B11E-0D3E-41E0-9C08-786C5CD0BF3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DF7BBFD8-EDC8-4B7B-AB28-7576198E0EB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377B5F8A-0CF7-48F1-A2F7-16FFA5A750E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14C2BD-E780-4893-B69C-FEB67E170F35}" type="datetimeFigureOut">
              <a:rPr lang="ko-KR" altLang="en-US" smtClean="0"/>
              <a:t>2021-01-06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9AB5B5DF-870E-43BE-8C18-595C3EFDA11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8029D744-F640-484F-B3AF-DF2FAD94D9E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6278D1-F831-4508-A8C3-E13F3D06CB6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01366280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F53A85F7-CB27-4167-A83C-AA6B5ECCD19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7D04DEFE-5F44-421C-9041-5167783BD9F1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내용 개체 틀 3">
            <a:extLst>
              <a:ext uri="{FF2B5EF4-FFF2-40B4-BE49-F238E27FC236}">
                <a16:creationId xmlns:a16="http://schemas.microsoft.com/office/drawing/2014/main" id="{A544D268-482B-4E83-81C4-8183C7C6133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BB2AE6A7-F42C-41A9-BD43-2A4A1950BC6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14C2BD-E780-4893-B69C-FEB67E170F35}" type="datetimeFigureOut">
              <a:rPr lang="ko-KR" altLang="en-US" smtClean="0"/>
              <a:t>2021-01-06</a:t>
            </a:fld>
            <a:endParaRPr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667CC7AF-9DEC-40AA-8C4A-8B11F0FC5CB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D1B96171-0491-46A9-88E8-FBB63DE1ED1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6278D1-F831-4508-A8C3-E13F3D06CB6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86539926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09BBAF36-35E9-4ABD-A658-1EC8B7951DF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7C7AFA3E-B3EB-41CB-97D8-9D98946452E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내용 개체 틀 3">
            <a:extLst>
              <a:ext uri="{FF2B5EF4-FFF2-40B4-BE49-F238E27FC236}">
                <a16:creationId xmlns:a16="http://schemas.microsoft.com/office/drawing/2014/main" id="{5987B508-8DC6-490C-B646-F5D970423BA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5" name="텍스트 개체 틀 4">
            <a:extLst>
              <a:ext uri="{FF2B5EF4-FFF2-40B4-BE49-F238E27FC236}">
                <a16:creationId xmlns:a16="http://schemas.microsoft.com/office/drawing/2014/main" id="{AB11E393-863F-45A5-8669-CDC3DD5DCC0D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6" name="내용 개체 틀 5">
            <a:extLst>
              <a:ext uri="{FF2B5EF4-FFF2-40B4-BE49-F238E27FC236}">
                <a16:creationId xmlns:a16="http://schemas.microsoft.com/office/drawing/2014/main" id="{7CDB996E-2F34-41A3-B53F-8CDE6F296369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7" name="날짜 개체 틀 6">
            <a:extLst>
              <a:ext uri="{FF2B5EF4-FFF2-40B4-BE49-F238E27FC236}">
                <a16:creationId xmlns:a16="http://schemas.microsoft.com/office/drawing/2014/main" id="{E3649D23-AB12-4E20-8C8B-6B3FAA0666B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14C2BD-E780-4893-B69C-FEB67E170F35}" type="datetimeFigureOut">
              <a:rPr lang="ko-KR" altLang="en-US" smtClean="0"/>
              <a:t>2021-01-06</a:t>
            </a:fld>
            <a:endParaRPr lang="ko-KR" altLang="en-US"/>
          </a:p>
        </p:txBody>
      </p:sp>
      <p:sp>
        <p:nvSpPr>
          <p:cNvPr id="8" name="바닥글 개체 틀 7">
            <a:extLst>
              <a:ext uri="{FF2B5EF4-FFF2-40B4-BE49-F238E27FC236}">
                <a16:creationId xmlns:a16="http://schemas.microsoft.com/office/drawing/2014/main" id="{E32F52CA-9EA9-45A6-87F0-331C31F3E70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>
            <a:extLst>
              <a:ext uri="{FF2B5EF4-FFF2-40B4-BE49-F238E27FC236}">
                <a16:creationId xmlns:a16="http://schemas.microsoft.com/office/drawing/2014/main" id="{34022620-CD77-45F8-9FFC-6D1E97E8BC0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6278D1-F831-4508-A8C3-E13F3D06CB6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9788928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07EAF1E1-8C09-401A-BDD3-149788DD47E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날짜 개체 틀 2">
            <a:extLst>
              <a:ext uri="{FF2B5EF4-FFF2-40B4-BE49-F238E27FC236}">
                <a16:creationId xmlns:a16="http://schemas.microsoft.com/office/drawing/2014/main" id="{C7CD27C1-A5FC-4430-9C4C-CD25F13643B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14C2BD-E780-4893-B69C-FEB67E170F35}" type="datetimeFigureOut">
              <a:rPr lang="ko-KR" altLang="en-US" smtClean="0"/>
              <a:t>2021-01-06</a:t>
            </a:fld>
            <a:endParaRPr lang="ko-KR" altLang="en-US"/>
          </a:p>
        </p:txBody>
      </p:sp>
      <p:sp>
        <p:nvSpPr>
          <p:cNvPr id="4" name="바닥글 개체 틀 3">
            <a:extLst>
              <a:ext uri="{FF2B5EF4-FFF2-40B4-BE49-F238E27FC236}">
                <a16:creationId xmlns:a16="http://schemas.microsoft.com/office/drawing/2014/main" id="{4638ADDC-85FF-4ED8-9F9B-AD96234315D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>
            <a:extLst>
              <a:ext uri="{FF2B5EF4-FFF2-40B4-BE49-F238E27FC236}">
                <a16:creationId xmlns:a16="http://schemas.microsoft.com/office/drawing/2014/main" id="{1B875CE6-36B6-40C6-80CE-D52CAC6F15F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6278D1-F831-4508-A8C3-E13F3D06CB6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9277032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>
            <a:extLst>
              <a:ext uri="{FF2B5EF4-FFF2-40B4-BE49-F238E27FC236}">
                <a16:creationId xmlns:a16="http://schemas.microsoft.com/office/drawing/2014/main" id="{8F2B77A1-13F0-4202-A962-1D6DE21BEA0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14C2BD-E780-4893-B69C-FEB67E170F35}" type="datetimeFigureOut">
              <a:rPr lang="ko-KR" altLang="en-US" smtClean="0"/>
              <a:t>2021-01-06</a:t>
            </a:fld>
            <a:endParaRPr lang="ko-KR" altLang="en-US"/>
          </a:p>
        </p:txBody>
      </p:sp>
      <p:sp>
        <p:nvSpPr>
          <p:cNvPr id="3" name="바닥글 개체 틀 2">
            <a:extLst>
              <a:ext uri="{FF2B5EF4-FFF2-40B4-BE49-F238E27FC236}">
                <a16:creationId xmlns:a16="http://schemas.microsoft.com/office/drawing/2014/main" id="{90B715CC-C33F-408C-84D4-473BEEE2246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>
            <a:extLst>
              <a:ext uri="{FF2B5EF4-FFF2-40B4-BE49-F238E27FC236}">
                <a16:creationId xmlns:a16="http://schemas.microsoft.com/office/drawing/2014/main" id="{560BE0F4-4C10-4CAC-B8D8-547B1D75E00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6278D1-F831-4508-A8C3-E13F3D06CB6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72804498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698BEE85-D98F-4DF1-8199-1C7D767EC7C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2C804BE3-BBBD-4DBA-BE61-1217AB86FB73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텍스트 개체 틀 3">
            <a:extLst>
              <a:ext uri="{FF2B5EF4-FFF2-40B4-BE49-F238E27FC236}">
                <a16:creationId xmlns:a16="http://schemas.microsoft.com/office/drawing/2014/main" id="{B2712B28-C8E2-4B4F-A6B4-39FA2A13A63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E240DE2C-388E-4FF5-B595-1D4C21E16DC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14C2BD-E780-4893-B69C-FEB67E170F35}" type="datetimeFigureOut">
              <a:rPr lang="ko-KR" altLang="en-US" smtClean="0"/>
              <a:t>2021-01-06</a:t>
            </a:fld>
            <a:endParaRPr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09A3D853-3902-43BE-B7DA-C59ACCF7C7E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1DE6D3E3-C664-47DD-972D-6352EBF0734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6278D1-F831-4508-A8C3-E13F3D06CB6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17315420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B318DEFA-0A0E-49AA-9DBD-601DE79C673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그림 개체 틀 2">
            <a:extLst>
              <a:ext uri="{FF2B5EF4-FFF2-40B4-BE49-F238E27FC236}">
                <a16:creationId xmlns:a16="http://schemas.microsoft.com/office/drawing/2014/main" id="{9C6F8082-344A-4613-B86A-60D2657FB6CD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>
            <a:extLst>
              <a:ext uri="{FF2B5EF4-FFF2-40B4-BE49-F238E27FC236}">
                <a16:creationId xmlns:a16="http://schemas.microsoft.com/office/drawing/2014/main" id="{0C019C90-36CA-4602-8959-3B5FBFBB74C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4AAC2BFA-D69A-429C-8BA0-009BFC26917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14C2BD-E780-4893-B69C-FEB67E170F35}" type="datetimeFigureOut">
              <a:rPr lang="ko-KR" altLang="en-US" smtClean="0"/>
              <a:t>2021-01-06</a:t>
            </a:fld>
            <a:endParaRPr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744314C5-D89E-483E-A75A-83D91D0F969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EA238B2C-4A3A-4144-B73F-92139D388CA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6278D1-F831-4508-A8C3-E13F3D06CB6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45007972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>
            <a:extLst>
              <a:ext uri="{FF2B5EF4-FFF2-40B4-BE49-F238E27FC236}">
                <a16:creationId xmlns:a16="http://schemas.microsoft.com/office/drawing/2014/main" id="{1DAA9CE8-C6CE-4810-BE41-37F375FB6A3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CFA107BE-8456-4C2F-9E9A-076E0F0678D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1BDA2D76-F8C2-4410-99F5-3A1C54C1EA5C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614C2BD-E780-4893-B69C-FEB67E170F35}" type="datetimeFigureOut">
              <a:rPr lang="ko-KR" altLang="en-US" smtClean="0"/>
              <a:t>2021-01-06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DE7364AA-D7E5-4712-814A-563D9F864EF2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BEC5E1A4-3A8E-4B50-8D9E-057A55707F5F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76278D1-F831-4508-A8C3-E13F3D06CB6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84911858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1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1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표 3">
            <a:extLst>
              <a:ext uri="{FF2B5EF4-FFF2-40B4-BE49-F238E27FC236}">
                <a16:creationId xmlns:a16="http://schemas.microsoft.com/office/drawing/2014/main" id="{0A070D21-0D95-4105-8C35-0E01A009A5E2}"/>
              </a:ext>
            </a:extLst>
          </p:cNvPr>
          <p:cNvGraphicFramePr>
            <a:graphicFrameLocks noGrp="1"/>
          </p:cNvGraphicFramePr>
          <p:nvPr/>
        </p:nvGraphicFramePr>
        <p:xfrm>
          <a:off x="901700" y="1604963"/>
          <a:ext cx="10388600" cy="3648075"/>
        </p:xfrm>
        <a:graphic>
          <a:graphicData uri="http://schemas.openxmlformats.org/drawingml/2006/table">
            <a:tbl>
              <a:tblPr/>
              <a:tblGrid>
                <a:gridCol w="1095040">
                  <a:extLst>
                    <a:ext uri="{9D8B030D-6E8A-4147-A177-3AD203B41FA5}">
                      <a16:colId xmlns:a16="http://schemas.microsoft.com/office/drawing/2014/main" val="2622279000"/>
                    </a:ext>
                  </a:extLst>
                </a:gridCol>
                <a:gridCol w="685590">
                  <a:extLst>
                    <a:ext uri="{9D8B030D-6E8A-4147-A177-3AD203B41FA5}">
                      <a16:colId xmlns:a16="http://schemas.microsoft.com/office/drawing/2014/main" val="295167366"/>
                    </a:ext>
                  </a:extLst>
                </a:gridCol>
                <a:gridCol w="1913940">
                  <a:extLst>
                    <a:ext uri="{9D8B030D-6E8A-4147-A177-3AD203B41FA5}">
                      <a16:colId xmlns:a16="http://schemas.microsoft.com/office/drawing/2014/main" val="2371986333"/>
                    </a:ext>
                  </a:extLst>
                </a:gridCol>
                <a:gridCol w="2618575">
                  <a:extLst>
                    <a:ext uri="{9D8B030D-6E8A-4147-A177-3AD203B41FA5}">
                      <a16:colId xmlns:a16="http://schemas.microsoft.com/office/drawing/2014/main" val="3103072260"/>
                    </a:ext>
                  </a:extLst>
                </a:gridCol>
                <a:gridCol w="2504310">
                  <a:extLst>
                    <a:ext uri="{9D8B030D-6E8A-4147-A177-3AD203B41FA5}">
                      <a16:colId xmlns:a16="http://schemas.microsoft.com/office/drawing/2014/main" val="3822322373"/>
                    </a:ext>
                  </a:extLst>
                </a:gridCol>
                <a:gridCol w="1571145">
                  <a:extLst>
                    <a:ext uri="{9D8B030D-6E8A-4147-A177-3AD203B41FA5}">
                      <a16:colId xmlns:a16="http://schemas.microsoft.com/office/drawing/2014/main" val="3256615406"/>
                    </a:ext>
                  </a:extLst>
                </a:gridCol>
              </a:tblGrid>
              <a:tr h="219075">
                <a:tc gridSpan="6">
                  <a:txBody>
                    <a:bodyPr/>
                    <a:lstStyle/>
                    <a:p>
                      <a:pPr algn="l" fontAlgn="ctr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Table 3.</a:t>
                      </a:r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 Comparison of FM concentration and calorific content of FM in the Southern Ocean (Ross Sea and Amundsen </a:t>
                      </a:r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Sea)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651350960"/>
                  </a:ext>
                </a:extLst>
              </a:tr>
              <a:tr h="57150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Year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Season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Region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1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FM concentraiton (μg L</a:t>
                      </a:r>
                      <a:r>
                        <a:rPr lang="fr-FR" sz="1100" b="1" i="0" u="none" strike="noStrike" baseline="300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-1</a:t>
                      </a:r>
                      <a:r>
                        <a:rPr lang="fr-FR" sz="11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)</a:t>
                      </a:r>
                      <a:br>
                        <a:rPr lang="fr-FR" sz="11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</a:br>
                      <a:r>
                        <a:rPr lang="fr-FR" sz="11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(Average </a:t>
                      </a:r>
                      <a:r>
                        <a:rPr lang="fr-FR" sz="1100" b="1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±</a:t>
                      </a:r>
                      <a:r>
                        <a:rPr lang="fr-FR" sz="11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 S.D.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Calorific content of FM (Kcal m</a:t>
                      </a:r>
                      <a:r>
                        <a:rPr lang="en-US" sz="1100" b="1" i="0" u="none" strike="noStrike" baseline="300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-3</a:t>
                      </a:r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)</a:t>
                      </a:r>
                      <a:br>
                        <a:rPr lang="en-US" sz="11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</a:br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(Average ± S.D.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References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360573970"/>
                  </a:ext>
                </a:extLst>
              </a:tr>
              <a:tr h="571500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1989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summer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Ross Sea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294.4 ± 228.1 (Photic layer)</a:t>
                      </a:r>
                      <a:b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</a:br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43.1 ± 18.2 (Aphotic layer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1.6 ± 1.3 (Photic layer)</a:t>
                      </a:r>
                      <a:b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</a:br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0.2 ± 0.1 (Aphotic layer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Fabiano et al. (1993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0724640"/>
                  </a:ext>
                </a:extLst>
              </a:tr>
              <a:tr h="571500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199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summer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Terra Nova Bay in Ross Sea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230 (whole water column)</a:t>
                      </a:r>
                    </a:p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374 (mixed layer)</a:t>
                      </a:r>
                    </a:p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171 (below</a:t>
                      </a:r>
                      <a:r>
                        <a:rPr lang="ko-KR" alt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 </a:t>
                      </a:r>
                      <a:r>
                        <a:rPr lang="en-US" altLang="ko-K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mixed</a:t>
                      </a:r>
                      <a:r>
                        <a:rPr lang="ko-KR" alt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 </a:t>
                      </a:r>
                      <a:r>
                        <a:rPr lang="en-US" altLang="ko-K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layer</a:t>
                      </a:r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1.3 ± 1.0 (whole water column)</a:t>
                      </a:r>
                      <a:b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</a:br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2.1 ± 0.9 (mixed layer)</a:t>
                      </a:r>
                      <a:b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</a:br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1.0 ± 0.4 (below mixed layer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Fabiano et al. (1996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712916952"/>
                  </a:ext>
                </a:extLst>
              </a:tr>
              <a:tr h="571500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2012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Feb.-Mar.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Amundsen sea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219.4 ± 151.1 (photic layer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1.3 ± 0.8 (photic layer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Kim et al. (2016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303365506"/>
                  </a:ext>
                </a:extLst>
              </a:tr>
              <a:tr h="571500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2013-2014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Dec.-Jan.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Amundsen sea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671.5 ± 311.8 (Photic layer)</a:t>
                      </a:r>
                      <a:b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</a:br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114.9 ± 99.4 (Aphotic layer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3.7 ± 1.6 (Photic layer)</a:t>
                      </a:r>
                      <a:b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</a:br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0.6 ± 0.6 (Aphotic layer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Kim et al. (2018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584901582"/>
                  </a:ext>
                </a:extLst>
              </a:tr>
              <a:tr h="571500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2015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Feb.-Oct.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Terra Nova Bay in Ross Sea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386.9 ± 194.2 (Ice-free period)</a:t>
                      </a:r>
                      <a:b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</a:br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121.1 ± 24.6 (Ice-covered period)</a:t>
                      </a:r>
                      <a:b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</a:br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150.6 ± 103.4 (Entire study period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2.3 ± 1.2 (Ice-free period)</a:t>
                      </a:r>
                      <a:b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</a:br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0.6 ± 0.1 (Ice-covered period)</a:t>
                      </a:r>
                      <a:b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</a:br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0.8 ± 0.7 (Entire study period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This study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296671659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428171677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맑은 고딕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73</TotalTime>
  <Words>288</Words>
  <Application>Microsoft Office PowerPoint</Application>
  <PresentationFormat>와이드스크린</PresentationFormat>
  <Paragraphs>39</Paragraphs>
  <Slides>1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3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1</vt:i4>
      </vt:variant>
    </vt:vector>
  </HeadingPairs>
  <TitlesOfParts>
    <vt:vector size="5" baseType="lpstr">
      <vt:lpstr>맑은 고딕</vt:lpstr>
      <vt:lpstr>Arial</vt:lpstr>
      <vt:lpstr>Times New Roman</vt:lpstr>
      <vt:lpstr>Office 테마</vt:lpstr>
      <vt:lpstr>PowerPoint 프레젠테이션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김관우</dc:creator>
  <cp:lastModifiedBy>김관우</cp:lastModifiedBy>
  <cp:revision>29</cp:revision>
  <cp:lastPrinted>2020-04-13T04:29:49Z</cp:lastPrinted>
  <dcterms:created xsi:type="dcterms:W3CDTF">2020-04-13T03:47:55Z</dcterms:created>
  <dcterms:modified xsi:type="dcterms:W3CDTF">2021-01-06T02:21:17Z</dcterms:modified>
</cp:coreProperties>
</file>